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D3F4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20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0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822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2600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928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038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112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349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4774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4149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724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1707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520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14AF7-A2C0-4B15-8C28-28E77D5CC5A8}" type="datetimeFigureOut">
              <a:rPr kumimoji="1" lang="ja-JP" altLang="en-US" smtClean="0"/>
              <a:t>2024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8B5BA-B1EC-424E-9DCD-164A283A95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8060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024CCCB-D252-4AC3-B09F-D7FD31746323}"/>
              </a:ext>
            </a:extLst>
          </p:cNvPr>
          <p:cNvSpPr txBox="1"/>
          <p:nvPr/>
        </p:nvSpPr>
        <p:spPr>
          <a:xfrm>
            <a:off x="0" y="0"/>
            <a:ext cx="4219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y Table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808AB9CB-C73D-4D22-8308-5338C0878551}"/>
              </a:ext>
            </a:extLst>
          </p:cNvPr>
          <p:cNvSpPr/>
          <p:nvPr/>
        </p:nvSpPr>
        <p:spPr>
          <a:xfrm>
            <a:off x="59195" y="304970"/>
            <a:ext cx="59466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use primers for quantitative real time PC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1425A39A-425A-9C26-F2C3-440D4D3B80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5658104"/>
              </p:ext>
            </p:extLst>
          </p:nvPr>
        </p:nvGraphicFramePr>
        <p:xfrm>
          <a:off x="93379" y="663508"/>
          <a:ext cx="6649613" cy="2261938"/>
        </p:xfrm>
        <a:graphic>
          <a:graphicData uri="http://schemas.openxmlformats.org/drawingml/2006/table">
            <a:tbl>
              <a:tblPr/>
              <a:tblGrid>
                <a:gridCol w="1171374">
                  <a:extLst>
                    <a:ext uri="{9D8B030D-6E8A-4147-A177-3AD203B41FA5}">
                      <a16:colId xmlns:a16="http://schemas.microsoft.com/office/drawing/2014/main" val="3167090592"/>
                    </a:ext>
                  </a:extLst>
                </a:gridCol>
                <a:gridCol w="2682446">
                  <a:extLst>
                    <a:ext uri="{9D8B030D-6E8A-4147-A177-3AD203B41FA5}">
                      <a16:colId xmlns:a16="http://schemas.microsoft.com/office/drawing/2014/main" val="724636775"/>
                    </a:ext>
                  </a:extLst>
                </a:gridCol>
                <a:gridCol w="2795793">
                  <a:extLst>
                    <a:ext uri="{9D8B030D-6E8A-4147-A177-3AD203B41FA5}">
                      <a16:colId xmlns:a16="http://schemas.microsoft.com/office/drawing/2014/main" val="1731749901"/>
                    </a:ext>
                  </a:extLst>
                </a:gridCol>
              </a:tblGrid>
              <a:tr h="354814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gene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Forward primer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Reverse primer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4915188"/>
                  </a:ext>
                </a:extLst>
              </a:tr>
              <a:tr h="310462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GAPDH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'-TGAAGCAGGCATCTGAGGG-3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'-CGAAGGTGGAAGAGTGGGAG-3'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1309236"/>
                  </a:ext>
                </a:extLst>
              </a:tr>
              <a:tr h="310462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Runx2 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'-CCTGAACTCTGCACCAAGTCCT-3'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'-TCATCTGGCTCAGATAGGAGGG-3'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1513845"/>
                  </a:ext>
                </a:extLst>
              </a:tr>
              <a:tr h="310462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PAI-1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’-CCTCTTCCACAAGTCTGATGGC-3’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’-GCAGTTCCACAACGTCATACTCG-3’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7593905"/>
                  </a:ext>
                </a:extLst>
              </a:tr>
              <a:tr h="310462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TGF-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β </a:t>
                      </a:r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RⅡ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'-GTCGGATGTGGAAATGGAAG-3'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'-CTGGCCATGACATCACTGTT-3'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511059"/>
                  </a:ext>
                </a:extLst>
              </a:tr>
              <a:tr h="310462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U6 snRNA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assay ID : 001973, TaqMan</a:t>
                      </a:r>
                      <a:r>
                        <a:rPr lang="en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TM</a:t>
                      </a:r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MicroRNA Assay (Thermo Fisher Scientific)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1145978"/>
                  </a:ext>
                </a:extLst>
              </a:tr>
              <a:tr h="354814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mmu-miR-17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assay ID : 002308, </a:t>
                      </a:r>
                      <a:r>
                        <a:rPr lang="en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TaqMan</a:t>
                      </a:r>
                      <a:r>
                        <a:rPr lang="en" sz="12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TM</a:t>
                      </a:r>
                      <a:r>
                        <a:rPr lang="en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MicroRNA</a:t>
                      </a:r>
                      <a:r>
                        <a:rPr lang="e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 Assay (</a:t>
                      </a:r>
                      <a:r>
                        <a:rPr lang="en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Thermo</a:t>
                      </a:r>
                      <a:r>
                        <a:rPr lang="e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 Fisher Scientific)</a:t>
                      </a:r>
                    </a:p>
                  </a:txBody>
                  <a:tcPr marL="7729" marR="7729" marT="772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E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43514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04338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1</TotalTime>
  <Words>78</Words>
  <Application>Microsoft Macintosh PowerPoint</Application>
  <PresentationFormat>A4 210 x 297 mm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馬場功士</dc:creator>
  <cp:lastModifiedBy>功士 馬場</cp:lastModifiedBy>
  <cp:revision>887</cp:revision>
  <dcterms:created xsi:type="dcterms:W3CDTF">2022-09-24T04:32:08Z</dcterms:created>
  <dcterms:modified xsi:type="dcterms:W3CDTF">2024-03-30T09:59:03Z</dcterms:modified>
</cp:coreProperties>
</file>